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57" r:id="rId3"/>
    <p:sldId id="258" r:id="rId4"/>
    <p:sldId id="260" r:id="rId5"/>
    <p:sldId id="261" r:id="rId6"/>
    <p:sldId id="264" r:id="rId7"/>
    <p:sldId id="259" r:id="rId8"/>
    <p:sldId id="262" r:id="rId9"/>
    <p:sldId id="263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4EC4DE-13D2-4A55-B402-A6D5D3F0D185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2BA56A-A01E-4199-913B-DE1A635C70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4108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8725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21895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47904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3470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63183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936208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023601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707564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BA56A-A01E-4199-913B-DE1A635C7076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9276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70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3704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9926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3212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2586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8576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49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424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880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3122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026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446EB-D34D-4936-9E3A-9798ECB258C6}" type="datetimeFigureOut">
              <a:rPr lang="en-GB" smtClean="0"/>
              <a:t>02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9CE38C-2DED-4E2D-9948-637F77DD8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4499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WB membrane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/>
              <a:t>For NAK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α1 and </a:t>
            </a:r>
            <a:r>
              <a:rPr lang="en-GB" dirty="0"/>
              <a:t>NAK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α2 molecular markers are indicated by arrows</a:t>
            </a:r>
          </a:p>
          <a:p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For all other proteins we show merged files with the weight of the molecular marker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549865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b="64961"/>
          <a:stretch/>
        </p:blipFill>
        <p:spPr>
          <a:xfrm>
            <a:off x="2333211" y="1929143"/>
            <a:ext cx="7380952" cy="1812008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A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3320560" y="2798883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3707422" y="3496414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957464" y="3345454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570602" y="2644994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</p:spTree>
    <p:extLst>
      <p:ext uri="{BB962C8B-B14F-4D97-AF65-F5344CB8AC3E}">
        <p14:creationId xmlns:p14="http://schemas.microsoft.com/office/powerpoint/2010/main" val="30048863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A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b="61561"/>
          <a:stretch/>
        </p:blipFill>
        <p:spPr>
          <a:xfrm>
            <a:off x="2405524" y="2118154"/>
            <a:ext cx="7380952" cy="1987856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>
            <a:off x="3320560" y="2778370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3320560" y="3001108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3707422" y="3672254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3710353" y="3877408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667314" y="2847219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75 kD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045384" y="3723519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75 kD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957464" y="3494918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570602" y="2618618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</p:spTree>
    <p:extLst>
      <p:ext uri="{BB962C8B-B14F-4D97-AF65-F5344CB8AC3E}">
        <p14:creationId xmlns:p14="http://schemas.microsoft.com/office/powerpoint/2010/main" val="12872162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12913" r="11921" b="68872"/>
          <a:stretch/>
        </p:blipFill>
        <p:spPr>
          <a:xfrm>
            <a:off x="3358662" y="2421527"/>
            <a:ext cx="5547946" cy="1609769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A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3631539" y="2653786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3628607" y="2943979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957464" y="2803233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7 kD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954526" y="2504340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50 kDa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3974440" y="3550648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3971508" y="3840841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300365" y="3700095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7 kD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297427" y="3401202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50 kDa</a:t>
            </a:r>
          </a:p>
        </p:txBody>
      </p:sp>
    </p:spTree>
    <p:extLst>
      <p:ext uri="{BB962C8B-B14F-4D97-AF65-F5344CB8AC3E}">
        <p14:creationId xmlns:p14="http://schemas.microsoft.com/office/powerpoint/2010/main" val="38963009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14224" r="11682" b="60711"/>
          <a:stretch/>
        </p:blipFill>
        <p:spPr>
          <a:xfrm>
            <a:off x="3361592" y="2095110"/>
            <a:ext cx="5468815" cy="20318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T4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3332601" y="2620643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3329669" y="2866876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658526" y="2717338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7 kD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655588" y="2471197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50 kDa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3734109" y="3412490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3731177" y="3658723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060034" y="3509185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7 kD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057096" y="3263044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50 kDa</a:t>
            </a:r>
          </a:p>
        </p:txBody>
      </p:sp>
    </p:spTree>
    <p:extLst>
      <p:ext uri="{BB962C8B-B14F-4D97-AF65-F5344CB8AC3E}">
        <p14:creationId xmlns:p14="http://schemas.microsoft.com/office/powerpoint/2010/main" val="37628882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10412" r="15495" b="54590"/>
          <a:stretch/>
        </p:blipFill>
        <p:spPr>
          <a:xfrm>
            <a:off x="3361592" y="1977492"/>
            <a:ext cx="5468815" cy="2348323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GB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3464474" y="2672282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3461542" y="2918515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790399" y="2768977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7 kD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787461" y="2522836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50 kDa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3778071" y="3711079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3775139" y="3957312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103996" y="3807774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7 kD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101058" y="3561633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50 kDa</a:t>
            </a:r>
          </a:p>
        </p:txBody>
      </p:sp>
    </p:spTree>
    <p:extLst>
      <p:ext uri="{BB962C8B-B14F-4D97-AF65-F5344CB8AC3E}">
        <p14:creationId xmlns:p14="http://schemas.microsoft.com/office/powerpoint/2010/main" val="28600993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C-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14462" r="14184" b="60201"/>
          <a:stretch/>
        </p:blipFill>
        <p:spPr>
          <a:xfrm>
            <a:off x="3472962" y="2091793"/>
            <a:ext cx="5266592" cy="2058177"/>
          </a:xfrm>
          <a:prstGeom prst="rect">
            <a:avLst/>
          </a:prstGeom>
        </p:spPr>
      </p:pic>
      <p:cxnSp>
        <p:nvCxnSpPr>
          <p:cNvPr id="4" name="Straight Arrow Connector 3"/>
          <p:cNvCxnSpPr/>
          <p:nvPr/>
        </p:nvCxnSpPr>
        <p:spPr>
          <a:xfrm>
            <a:off x="3417275" y="2822331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>
            <a:off x="3417275" y="3045069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3804137" y="3716215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3807068" y="3921369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764029" y="2891180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75 kD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142099" y="3767480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75 kD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054179" y="3538879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667317" y="2662579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3417275" y="2609827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667317" y="2463195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50 kDa</a:t>
            </a: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3804137" y="3512503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042454" y="3362309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50 kDa</a:t>
            </a:r>
          </a:p>
        </p:txBody>
      </p:sp>
    </p:spTree>
    <p:extLst>
      <p:ext uri="{BB962C8B-B14F-4D97-AF65-F5344CB8AC3E}">
        <p14:creationId xmlns:p14="http://schemas.microsoft.com/office/powerpoint/2010/main" val="16015407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10888" r="12636" b="62581"/>
          <a:stretch/>
        </p:blipFill>
        <p:spPr>
          <a:xfrm>
            <a:off x="3273669" y="2187454"/>
            <a:ext cx="5644662" cy="193508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NHE1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3513991" y="2757830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3513991" y="2980568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3760174" y="3601918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3763105" y="3807072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860745" y="2826679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75 kD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098136" y="3653183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75 kD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010216" y="3424582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764033" y="2598078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</p:spTree>
    <p:extLst>
      <p:ext uri="{BB962C8B-B14F-4D97-AF65-F5344CB8AC3E}">
        <p14:creationId xmlns:p14="http://schemas.microsoft.com/office/powerpoint/2010/main" val="37774204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l="11365" r="13589" b="54251"/>
          <a:stretch/>
        </p:blipFill>
        <p:spPr>
          <a:xfrm>
            <a:off x="3326423" y="1862114"/>
            <a:ext cx="5539153" cy="2365907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MHCIIa</a:t>
            </a:r>
          </a:p>
        </p:txBody>
      </p:sp>
      <p:cxnSp>
        <p:nvCxnSpPr>
          <p:cNvPr id="4" name="Straight Arrow Connector 3"/>
          <p:cNvCxnSpPr/>
          <p:nvPr/>
        </p:nvCxnSpPr>
        <p:spPr>
          <a:xfrm>
            <a:off x="3297431" y="2590707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>
            <a:off x="3297431" y="2859257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570600" y="2706544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570600" y="2446174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50 kDa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3297431" y="2293304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570600" y="2149510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250 kDa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3792731" y="3674591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3792731" y="3943141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065900" y="3790428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00 kD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065900" y="3530058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50 kDa</a:t>
            </a: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3792731" y="3377188"/>
            <a:ext cx="3868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065900" y="3233394"/>
            <a:ext cx="8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250 kDa</a:t>
            </a:r>
          </a:p>
        </p:txBody>
      </p:sp>
    </p:spTree>
    <p:extLst>
      <p:ext uri="{BB962C8B-B14F-4D97-AF65-F5344CB8AC3E}">
        <p14:creationId xmlns:p14="http://schemas.microsoft.com/office/powerpoint/2010/main" val="4050707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9</TotalTime>
  <Words>118</Words>
  <Application>Microsoft Office PowerPoint</Application>
  <PresentationFormat>Widescreen</PresentationFormat>
  <Paragraphs>54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WB membranes</vt:lpstr>
      <vt:lpstr>NKAα1</vt:lpstr>
      <vt:lpstr>NKAα2</vt:lpstr>
      <vt:lpstr>NKAβ1</vt:lpstr>
      <vt:lpstr>MCT4</vt:lpstr>
      <vt:lpstr>KATP</vt:lpstr>
      <vt:lpstr>ClC-1</vt:lpstr>
      <vt:lpstr>NHE1</vt:lpstr>
      <vt:lpstr>MHCIIa</vt:lpstr>
    </vt:vector>
  </TitlesOfParts>
  <Company>SUND - K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B membranes</dc:title>
  <dc:creator>Martin Thomassen</dc:creator>
  <cp:lastModifiedBy>Jeppe Foged Vigh-Larsen</cp:lastModifiedBy>
  <cp:revision>13</cp:revision>
  <dcterms:created xsi:type="dcterms:W3CDTF">2024-08-22T08:56:52Z</dcterms:created>
  <dcterms:modified xsi:type="dcterms:W3CDTF">2024-09-02T11:39:37Z</dcterms:modified>
</cp:coreProperties>
</file>